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6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1541" y="-7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494BDC-55A3-4BA8-8179-A1E1E6EBEC2C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3934C4-1469-406F-9BD4-BF976DD055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2513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6102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5253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23849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737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435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3007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9254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9927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7208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5730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1878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5277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1596230"/>
              </p:ext>
            </p:extLst>
          </p:nvPr>
        </p:nvGraphicFramePr>
        <p:xfrm>
          <a:off x="80720" y="395536"/>
          <a:ext cx="6696744" cy="3986046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504056"/>
                <a:gridCol w="288032"/>
                <a:gridCol w="576064"/>
                <a:gridCol w="576064"/>
                <a:gridCol w="216024"/>
                <a:gridCol w="360040"/>
                <a:gridCol w="360040"/>
                <a:gridCol w="648072"/>
                <a:gridCol w="360040"/>
                <a:gridCol w="288032"/>
                <a:gridCol w="216024"/>
                <a:gridCol w="216024"/>
                <a:gridCol w="216024"/>
                <a:gridCol w="360040"/>
                <a:gridCol w="432048"/>
                <a:gridCol w="504056"/>
                <a:gridCol w="576064"/>
              </a:tblGrid>
              <a:tr h="4456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Classified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CXR Stage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Active changes on CT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Respiratory</a:t>
                      </a:r>
                    </a:p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Symptoms </a:t>
                      </a:r>
                      <a:r>
                        <a:rPr lang="en-GB" sz="900" u="none" strike="noStrike" dirty="0">
                          <a:effectLst/>
                        </a:rPr>
                        <a:t>Changed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E 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Lymph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eut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Other organ </a:t>
                      </a:r>
                      <a:r>
                        <a:rPr lang="en-GB" sz="900" u="none" strike="noStrike" dirty="0" smtClean="0">
                          <a:effectLst/>
                        </a:rPr>
                        <a:t>involved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Fatigue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TLCO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KCO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FVC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FEV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FEV1</a:t>
                      </a:r>
                      <a:r>
                        <a:rPr lang="en-GB" sz="900" u="none" strike="noStrike" dirty="0" smtClean="0">
                          <a:effectLst/>
                        </a:rPr>
                        <a:t>/</a:t>
                      </a:r>
                    </a:p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FVC </a:t>
                      </a:r>
                      <a:r>
                        <a:rPr lang="en-GB" sz="900" u="none" strike="noStrike" dirty="0">
                          <a:effectLst/>
                        </a:rPr>
                        <a:t>%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Organ biopsied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Length of disease (years)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Therapy</a:t>
                      </a:r>
                    </a:p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started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.8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.5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Parotid,</a:t>
                      </a:r>
                      <a:r>
                        <a:rPr lang="en-GB" sz="900" u="none" strike="noStrike" baseline="0" dirty="0" smtClean="0">
                          <a:effectLst/>
                        </a:rPr>
                        <a:t> skin</a:t>
                      </a:r>
                      <a:r>
                        <a:rPr lang="en-GB" sz="900" u="none" strike="noStrike" dirty="0" smtClean="0">
                          <a:effectLst/>
                        </a:rPr>
                        <a:t>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3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Parotid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16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.4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Skin,</a:t>
                      </a:r>
                      <a:r>
                        <a:rPr lang="en-GB" sz="900" u="none" strike="noStrike" baseline="0" dirty="0" smtClean="0">
                          <a:effectLst/>
                        </a:rPr>
                        <a:t> </a:t>
                      </a:r>
                      <a:r>
                        <a:rPr lang="en-GB" sz="900" u="none" strike="noStrike" baseline="0" dirty="0" err="1" smtClean="0">
                          <a:effectLst/>
                        </a:rPr>
                        <a:t>abdo</a:t>
                      </a:r>
                      <a:r>
                        <a:rPr lang="en-GB" sz="900" u="none" strike="noStrike" dirty="0" smtClean="0">
                          <a:effectLst/>
                        </a:rPr>
                        <a:t>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Liver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19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.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Lung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.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.4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4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4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/A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2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Ye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Acti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Yes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Yes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10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0.9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7.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Ski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Lung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2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3.6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Lung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4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.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5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Skin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8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3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u="none" strike="noStrike" dirty="0" smtClean="0">
                          <a:effectLst/>
                        </a:rPr>
                        <a:t>Med LN</a:t>
                      </a:r>
                      <a:endParaRPr lang="en-GB" sz="9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4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.7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Skin,</a:t>
                      </a:r>
                      <a:r>
                        <a:rPr lang="en-GB" sz="900" u="none" strike="noStrike" baseline="0" dirty="0" smtClean="0">
                          <a:effectLst/>
                        </a:rPr>
                        <a:t> joint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LN Other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2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.9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smtClean="0">
                          <a:effectLst/>
                        </a:rPr>
                        <a:t>Med L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111412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8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9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smtClean="0">
                          <a:effectLst/>
                        </a:rPr>
                        <a:t>Med L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3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.1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0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smtClean="0">
                          <a:effectLst/>
                        </a:rPr>
                        <a:t>Med L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.1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smtClean="0">
                          <a:effectLst/>
                        </a:rPr>
                        <a:t>Med L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115868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0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4.5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Med L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467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.6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1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Lung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2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.4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LN Other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0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8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3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Lung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.6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.2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Eyes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Lung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93586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.6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.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Med L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12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.6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7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Lung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9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Med L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3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5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Skin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.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Med L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.1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Lung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  <a:tr h="89129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5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.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Eyes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Med L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5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56" marR="4456" marT="4456" marB="0" anchor="ctr"/>
                </a:tc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8765111"/>
              </p:ext>
            </p:extLst>
          </p:nvPr>
        </p:nvGraphicFramePr>
        <p:xfrm>
          <a:off x="115069" y="4966470"/>
          <a:ext cx="6651350" cy="3998560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496840"/>
                <a:gridCol w="300220"/>
                <a:gridCol w="525385"/>
                <a:gridCol w="600440"/>
                <a:gridCol w="225165"/>
                <a:gridCol w="375275"/>
                <a:gridCol w="300220"/>
                <a:gridCol w="600440"/>
                <a:gridCol w="375275"/>
                <a:gridCol w="300220"/>
                <a:gridCol w="225165"/>
                <a:gridCol w="300220"/>
                <a:gridCol w="225165"/>
                <a:gridCol w="375275"/>
                <a:gridCol w="450330"/>
                <a:gridCol w="525385"/>
                <a:gridCol w="450330"/>
              </a:tblGrid>
              <a:tr h="37695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Classified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CXR Stage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Active changes on CT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Respiratory </a:t>
                      </a:r>
                      <a:r>
                        <a:rPr lang="en-GB" sz="900" u="none" strike="noStrike" dirty="0">
                          <a:effectLst/>
                        </a:rPr>
                        <a:t>Symptoms Changed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E 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Lymph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eut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Other organ involved 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Fatigue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TLCO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KCO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FVC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FEV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FEV1</a:t>
                      </a:r>
                      <a:r>
                        <a:rPr lang="en-GB" sz="900" u="none" strike="noStrike" dirty="0" smtClean="0">
                          <a:effectLst/>
                        </a:rPr>
                        <a:t>/</a:t>
                      </a:r>
                    </a:p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FVC </a:t>
                      </a:r>
                      <a:r>
                        <a:rPr lang="en-GB" sz="900" u="none" strike="noStrike" dirty="0">
                          <a:effectLst/>
                        </a:rPr>
                        <a:t>%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Organ biopsied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Length of disease (years)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Therapy</a:t>
                      </a:r>
                      <a:r>
                        <a:rPr lang="en-GB" sz="900" u="none" strike="noStrike" baseline="0" dirty="0" smtClean="0">
                          <a:effectLst/>
                        </a:rPr>
                        <a:t> s</a:t>
                      </a:r>
                      <a:r>
                        <a:rPr lang="en-GB" sz="900" u="none" strike="noStrike" dirty="0" smtClean="0">
                          <a:effectLst/>
                        </a:rPr>
                        <a:t>tarted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6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3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.7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Ski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6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.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7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7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8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Ski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189915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.8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9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Joint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10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10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9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7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Med L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5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4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.4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Joint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7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9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9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9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8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Med L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6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.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N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10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Med L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4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N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.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Lung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.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N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Med L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.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N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Med L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.3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3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Skin, </a:t>
                      </a:r>
                      <a:r>
                        <a:rPr lang="en-GB" sz="900" u="none" strike="noStrike" dirty="0" err="1" smtClean="0">
                          <a:effectLst/>
                        </a:rPr>
                        <a:t>neur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err="1" smtClean="0">
                          <a:effectLst/>
                        </a:rPr>
                        <a:t>Cerv</a:t>
                      </a:r>
                      <a:r>
                        <a:rPr lang="en-GB" sz="900" u="none" strike="noStrike" dirty="0" smtClean="0">
                          <a:effectLst/>
                        </a:rPr>
                        <a:t> </a:t>
                      </a:r>
                      <a:r>
                        <a:rPr lang="en-GB" sz="900" u="none" strike="noStrike" dirty="0">
                          <a:effectLst/>
                        </a:rPr>
                        <a:t>L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3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.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Joint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7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9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9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9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8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err="1" smtClean="0">
                          <a:effectLst/>
                        </a:rPr>
                        <a:t>Ing</a:t>
                      </a:r>
                      <a:r>
                        <a:rPr lang="en-GB" sz="900" u="none" strike="noStrike" dirty="0" smtClean="0">
                          <a:effectLst/>
                        </a:rPr>
                        <a:t> </a:t>
                      </a:r>
                      <a:r>
                        <a:rPr lang="en-GB" sz="900" u="none" strike="noStrike" dirty="0">
                          <a:effectLst/>
                        </a:rPr>
                        <a:t>L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Ye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.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Lun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.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.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Lun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.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Med L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AET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Ski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Ski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Decline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Acti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6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3.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Eye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Lun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Acti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3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.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Ski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Acti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.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Med L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NA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.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Med L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3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Acti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.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Lun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Decline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AET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.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Ski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Med L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.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Med L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Med L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3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ski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Live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.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Med L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.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Med L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  <a:tr h="963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N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.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.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N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-99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Lun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N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213" marR="4213" marT="4213" marB="0" anchor="ctr"/>
                </a:tc>
              </a:tr>
            </a:tbl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14461" y="4569442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3B</a:t>
            </a:r>
            <a:endParaRPr lang="en-GB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-27384" y="-36512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3A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8796191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9879169"/>
              </p:ext>
            </p:extLst>
          </p:nvPr>
        </p:nvGraphicFramePr>
        <p:xfrm>
          <a:off x="56981" y="527195"/>
          <a:ext cx="6741369" cy="2202960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503567"/>
                <a:gridCol w="304283"/>
                <a:gridCol w="456425"/>
                <a:gridCol w="608566"/>
                <a:gridCol w="228212"/>
                <a:gridCol w="380354"/>
                <a:gridCol w="304283"/>
                <a:gridCol w="684637"/>
                <a:gridCol w="380354"/>
                <a:gridCol w="304283"/>
                <a:gridCol w="228212"/>
                <a:gridCol w="228212"/>
                <a:gridCol w="225247"/>
                <a:gridCol w="383319"/>
                <a:gridCol w="456425"/>
                <a:gridCol w="532495"/>
                <a:gridCol w="532495"/>
              </a:tblGrid>
              <a:tr h="36529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Classified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CXR Stage 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Active changes on CT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Respiratory Symptoms Changed 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E 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Lymph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eut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Other organ involved 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Fatigue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TLCO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KCO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FVC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FEV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FEV1/</a:t>
                      </a:r>
                      <a:br>
                        <a:rPr lang="en-GB" sz="900" u="none" strike="noStrike">
                          <a:effectLst/>
                        </a:rPr>
                      </a:br>
                      <a:r>
                        <a:rPr lang="en-GB" sz="900" u="none" strike="noStrike">
                          <a:effectLst/>
                        </a:rPr>
                        <a:t>FVC %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Organ biopsied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Length of disease (months)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Therapy started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</a:tr>
              <a:tr h="100771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.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.0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.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Ski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Lun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</a:tr>
              <a:tr h="188945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4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.1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.4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Abdomen, cervical </a:t>
                      </a:r>
                      <a:r>
                        <a:rPr lang="en-GB" sz="900" u="none" strike="noStrike" dirty="0">
                          <a:effectLst/>
                        </a:rPr>
                        <a:t>L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Lung &amp; </a:t>
                      </a:r>
                      <a:r>
                        <a:rPr lang="en-GB" sz="900" u="none" strike="noStrike" dirty="0">
                          <a:effectLst/>
                        </a:rPr>
                        <a:t>liver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Ye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</a:tr>
              <a:tr h="100771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0.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.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Abdome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0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Lung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</a:tr>
              <a:tr h="188945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.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.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Lung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</a:tr>
              <a:tr h="100771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.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0.4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5.5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Lung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</a:tr>
              <a:tr h="100771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AET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.8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.5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Parotid</a:t>
                      </a:r>
                      <a:r>
                        <a:rPr lang="en-GB" sz="900" u="none" strike="noStrike" dirty="0">
                          <a:effectLst/>
                        </a:rPr>
                        <a:t>, liver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Lung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</a:tr>
              <a:tr h="100771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.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.2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.6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Joint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1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Med L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</a:tr>
              <a:tr h="100771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.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0.8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.1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Ski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Lung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</a:tr>
              <a:tr h="188945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.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4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.4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.7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Joint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Med L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</a:tr>
              <a:tr h="100771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>
                          <a:effectLst/>
                        </a:rPr>
                        <a:t>.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No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.3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.9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9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8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7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6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Lun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</a:tr>
              <a:tr h="100771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Acti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7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.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2.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Lun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>
                          <a:effectLst/>
                        </a:rPr>
                        <a:t>1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>
                          <a:effectLst/>
                        </a:rPr>
                        <a:t>Decline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199" marR="4199" marT="4199" marB="0" anchor="ctr"/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3519778"/>
              </p:ext>
            </p:extLst>
          </p:nvPr>
        </p:nvGraphicFramePr>
        <p:xfrm>
          <a:off x="404664" y="3884084"/>
          <a:ext cx="5544616" cy="1831810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1512167"/>
                <a:gridCol w="1905747"/>
                <a:gridCol w="2126702"/>
              </a:tblGrid>
              <a:tr h="34591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  </a:t>
                      </a:r>
                      <a:endParaRPr lang="en-GB" sz="16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Active Sarcoidosis</a:t>
                      </a:r>
                      <a:endParaRPr lang="en-GB" sz="16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Non-active sarcoidosis</a:t>
                      </a:r>
                      <a:endParaRPr lang="en-GB" sz="16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/>
                </a:tc>
              </a:tr>
              <a:tr h="206378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Number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39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22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/>
                </a:tc>
              </a:tr>
              <a:tr h="206378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Gender (% male)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41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59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/>
                </a:tc>
              </a:tr>
              <a:tr h="825510"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Ethnicity (%)</a:t>
                      </a:r>
                      <a:br>
                        <a:rPr lang="en-GB" sz="1600" u="none" strike="noStrike" dirty="0">
                          <a:effectLst/>
                        </a:rPr>
                      </a:br>
                      <a:r>
                        <a:rPr lang="en-GB" sz="1600" u="none" strike="noStrike" dirty="0">
                          <a:effectLst/>
                        </a:rPr>
                        <a:t>- White</a:t>
                      </a:r>
                      <a:br>
                        <a:rPr lang="en-GB" sz="1600" u="none" strike="noStrike" dirty="0">
                          <a:effectLst/>
                        </a:rPr>
                      </a:br>
                      <a:r>
                        <a:rPr lang="en-GB" sz="1600" u="none" strike="noStrike" dirty="0">
                          <a:effectLst/>
                        </a:rPr>
                        <a:t>- Black</a:t>
                      </a:r>
                      <a:br>
                        <a:rPr lang="en-GB" sz="1600" u="none" strike="noStrike" dirty="0">
                          <a:effectLst/>
                        </a:rPr>
                      </a:br>
                      <a:r>
                        <a:rPr lang="en-GB" sz="1600" u="none" strike="noStrike" dirty="0">
                          <a:effectLst/>
                        </a:rPr>
                        <a:t>- ISC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>
                          <a:effectLst/>
                        </a:rPr>
                        <a:t>44</a:t>
                      </a:r>
                      <a:br>
                        <a:rPr lang="en-GB" sz="1600" u="none" strike="noStrike">
                          <a:effectLst/>
                        </a:rPr>
                      </a:br>
                      <a:r>
                        <a:rPr lang="en-GB" sz="1600" u="none" strike="noStrike">
                          <a:effectLst/>
                        </a:rPr>
                        <a:t>36</a:t>
                      </a:r>
                      <a:br>
                        <a:rPr lang="en-GB" sz="1600" u="none" strike="noStrike">
                          <a:effectLst/>
                        </a:rPr>
                      </a:br>
                      <a:r>
                        <a:rPr lang="en-GB" sz="1600" u="none" strike="noStrike">
                          <a:effectLst/>
                        </a:rPr>
                        <a:t>15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u="none" strike="noStrike" dirty="0">
                          <a:effectLst/>
                        </a:rPr>
                        <a:t>64</a:t>
                      </a:r>
                      <a:br>
                        <a:rPr lang="en-GB" sz="1600" u="none" strike="noStrike" dirty="0">
                          <a:effectLst/>
                        </a:rPr>
                      </a:br>
                      <a:r>
                        <a:rPr lang="en-GB" sz="1600" u="none" strike="noStrike" dirty="0">
                          <a:effectLst/>
                        </a:rPr>
                        <a:t>18</a:t>
                      </a:r>
                      <a:br>
                        <a:rPr lang="en-GB" sz="1600" u="none" strike="noStrike" dirty="0">
                          <a:effectLst/>
                        </a:rPr>
                      </a:br>
                      <a:r>
                        <a:rPr lang="en-GB" sz="1600" u="none" strike="noStrike" dirty="0">
                          <a:effectLst/>
                        </a:rPr>
                        <a:t>18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14461" y="98212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3C</a:t>
            </a:r>
            <a:endParaRPr lang="en-GB" b="1" dirty="0"/>
          </a:p>
        </p:txBody>
      </p:sp>
      <p:sp>
        <p:nvSpPr>
          <p:cNvPr id="8" name="TextBox 7"/>
          <p:cNvSpPr txBox="1"/>
          <p:nvPr/>
        </p:nvSpPr>
        <p:spPr>
          <a:xfrm>
            <a:off x="7341" y="3482588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3D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7535421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207</Words>
  <Application>Microsoft Office PowerPoint</Application>
  <PresentationFormat>On-screen Show (4:3)</PresentationFormat>
  <Paragraphs>1104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oom</dc:creator>
  <cp:lastModifiedBy>Bloom</cp:lastModifiedBy>
  <cp:revision>4</cp:revision>
  <dcterms:created xsi:type="dcterms:W3CDTF">2013-03-09T22:22:05Z</dcterms:created>
  <dcterms:modified xsi:type="dcterms:W3CDTF">2013-03-09T22:25:29Z</dcterms:modified>
</cp:coreProperties>
</file>